
<file path=[Content_Types].xml><?xml version="1.0" encoding="utf-8"?>
<Types xmlns="http://schemas.openxmlformats.org/package/2006/content-types">
  <Default Extension="emf" ContentType="image/x-emf"/>
  <Default Extension="fntdata" ContentType="application/x-fontdata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83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  <p:embeddedFont>
      <p:font typeface="Helvetica" pitchFamily="2" charset="0"/>
      <p:regular r:id="rId10"/>
      <p:bold r:id="rId11"/>
      <p:italic r:id="rId12"/>
      <p:boldItalic r:id="rId13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20" userDrawn="1">
          <p15:clr>
            <a:srgbClr val="A4A3A4"/>
          </p15:clr>
        </p15:guide>
        <p15:guide id="2" pos="2069" userDrawn="1">
          <p15:clr>
            <a:srgbClr val="A4A3A4"/>
          </p15:clr>
        </p15:guide>
        <p15:guide id="3" pos="234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918A"/>
    <a:srgbClr val="ADD9C8"/>
    <a:srgbClr val="BDD9D9"/>
    <a:srgbClr val="FFF0EE"/>
    <a:srgbClr val="FDE1DC"/>
    <a:srgbClr val="FAD1CC"/>
    <a:srgbClr val="FAC2BA"/>
    <a:srgbClr val="F0978A"/>
    <a:srgbClr val="EB877A"/>
    <a:srgbClr val="E678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5647" autoAdjust="0"/>
  </p:normalViewPr>
  <p:slideViewPr>
    <p:cSldViewPr snapToGrid="0" showGuides="1">
      <p:cViewPr>
        <p:scale>
          <a:sx n="75" d="100"/>
          <a:sy n="75" d="100"/>
        </p:scale>
        <p:origin x="1824" y="-1242"/>
      </p:cViewPr>
      <p:guideLst>
        <p:guide orient="horz" pos="5320"/>
        <p:guide pos="2069"/>
        <p:guide pos="23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font" Target="fonts/font10.fntdata"/><Relationship Id="rId1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font" Target="fonts/font9.fntdata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presProps" Target="presProps.xml"/><Relationship Id="rId10" Type="http://schemas.openxmlformats.org/officeDocument/2006/relationships/font" Target="fonts/font7.fntdata"/><Relationship Id="rId19" Type="http://schemas.microsoft.com/office/2018/10/relationships/authors" Target="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2523961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8">
            <a:extLst>
              <a:ext uri="{FF2B5EF4-FFF2-40B4-BE49-F238E27FC236}">
                <a16:creationId xmlns:a16="http://schemas.microsoft.com/office/drawing/2014/main" id="{080D87EE-5FDF-9659-8DB4-ED5AA3D5D7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5322" y="645137"/>
            <a:ext cx="3497580" cy="2914650"/>
          </a:xfrm>
          <a:prstGeom prst="rect">
            <a:avLst/>
          </a:prstGeom>
        </p:spPr>
      </p:pic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1908" y="6615093"/>
            <a:ext cx="575418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9 |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ple of correlated metabolite and enriched reaction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the average normalized intensity of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curbitoside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 per species. Normalized intensity of all metabolites are provided in Dussarrat et al., 2022. 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umber of gene isoforms per reaction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sus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rmalized metabolite intensity.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ol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ccharis tol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qu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strephi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uadrangularis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gmul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getes multiflor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bart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brosia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temisioides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mon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chopsis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cephal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bden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biana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udat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ch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anum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lense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pin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celia pinnatifid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mb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riplex imbricat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cbry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cnophyllum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yoides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esp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esmi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nosissim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psub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pinus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inflatus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gch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goni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ilensis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cr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amagrostis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isp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rfr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rav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igid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iads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istida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scensionis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472D7B-D1C5-4727-8B5F-F2552A5C67D8}"/>
              </a:ext>
            </a:extLst>
          </p:cNvPr>
          <p:cNvSpPr/>
          <p:nvPr/>
        </p:nvSpPr>
        <p:spPr>
          <a:xfrm>
            <a:off x="545550" y="532865"/>
            <a:ext cx="5760000" cy="6082227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845EABD9-710F-58CF-F157-DFC60B641BA3}"/>
              </a:ext>
            </a:extLst>
          </p:cNvPr>
          <p:cNvSpPr txBox="1"/>
          <p:nvPr/>
        </p:nvSpPr>
        <p:spPr>
          <a:xfrm>
            <a:off x="510509" y="50663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a</a:t>
            </a:r>
          </a:p>
        </p:txBody>
      </p:sp>
      <p:pic>
        <p:nvPicPr>
          <p:cNvPr id="9" name="Picture 15">
            <a:extLst>
              <a:ext uri="{FF2B5EF4-FFF2-40B4-BE49-F238E27FC236}">
                <a16:creationId xmlns:a16="http://schemas.microsoft.com/office/drawing/2014/main" id="{D3FB8264-231D-8150-E0C7-6A1CD9F10F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5322" y="3652689"/>
            <a:ext cx="3497580" cy="291465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F830BB70-EBA2-849C-7FCD-64F7FAF593FB}"/>
              </a:ext>
            </a:extLst>
          </p:cNvPr>
          <p:cNvSpPr txBox="1"/>
          <p:nvPr/>
        </p:nvSpPr>
        <p:spPr>
          <a:xfrm>
            <a:off x="505700" y="349385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041023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28</TotalTime>
  <Words>136</Words>
  <Application>Microsoft Office PowerPoint</Application>
  <PresentationFormat>Format A4 (210 x 297 mm)</PresentationFormat>
  <Paragraphs>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Calibri</vt:lpstr>
      <vt:lpstr>Helvetica</vt:lpstr>
      <vt:lpstr>Arial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369</cp:revision>
  <dcterms:created xsi:type="dcterms:W3CDTF">2020-07-29T08:33:47Z</dcterms:created>
  <dcterms:modified xsi:type="dcterms:W3CDTF">2023-08-23T12:46:09Z</dcterms:modified>
</cp:coreProperties>
</file>